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73" r:id="rId2"/>
    <p:sldId id="263" r:id="rId3"/>
    <p:sldId id="267" r:id="rId4"/>
    <p:sldId id="272" r:id="rId5"/>
    <p:sldId id="269" r:id="rId6"/>
    <p:sldId id="270" r:id="rId7"/>
    <p:sldId id="271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71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10" Type="http://schemas.openxmlformats.org/officeDocument/2006/relationships/presProps" Target="presProps.xml"/>
   <Relationship Id="rId11" Type="http://schemas.openxmlformats.org/officeDocument/2006/relationships/viewProps" Target="viewProps.xml"/>
   <Relationship Id="rId12" Type="http://schemas.openxmlformats.org/officeDocument/2006/relationships/theme" Target="theme/theme1.xml"/>
   <Relationship Id="rId13" Type="http://schemas.openxmlformats.org/officeDocument/2006/relationships/tableStyles" Target="tableStyles.xml"/>
   <Relationship Id="rId2" Type="http://schemas.openxmlformats.org/officeDocument/2006/relationships/slide" Target="slides/slide1.xml"/>
   <Relationship Id="rId3" Type="http://schemas.openxmlformats.org/officeDocument/2006/relationships/slide" Target="slides/slide2.xml"/>
   <Relationship Id="rId4" Type="http://schemas.openxmlformats.org/officeDocument/2006/relationships/slide" Target="slides/slide3.xml"/>
   <Relationship Id="rId5" Type="http://schemas.openxmlformats.org/officeDocument/2006/relationships/slide" Target="slides/slide4.xml"/>
   <Relationship Id="rId6" Type="http://schemas.openxmlformats.org/officeDocument/2006/relationships/slide" Target="slides/slide5.xml"/>
   <Relationship Id="rId7" Type="http://schemas.openxmlformats.org/officeDocument/2006/relationships/slide" Target="slides/slide6.xml"/>
   <Relationship Id="rId8" Type="http://schemas.openxmlformats.org/officeDocument/2006/relationships/slide" Target="slides/slide7.xml"/>
   <Relationship Id="rId9" Type="http://schemas.openxmlformats.org/officeDocument/2006/relationships/notesMaster" Target="notesMasters/notesMaster1.xml"/>
</Relationships>
</file>

<file path=ppt/notesMasters/_rels/notesMaster1.xml.rels><?xml version = '1.0' encoding = 'UTF-8' standalone = 'yes'?>
<Relationships xmlns="http://schemas.openxmlformats.org/package/2006/relationships">
   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BA0860-CD0F-4111-A88D-97823E48FAA2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26E606-3D27-4AB1-8873-A0DD79BBB6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1197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 = '1.0' encoding = 'UTF-8' standalone = 'yes'?>
<Relationships xmlns="http://schemas.openxmlformats.org/package/2006/relationships">
   <Relationship Id="rId1" Type="http://schemas.openxmlformats.org/officeDocument/2006/relationships/notesMaster" Target="../notesMasters/notesMaster1.xml"/>
   <Relationship Id="rId2" Type="http://schemas.openxmlformats.org/officeDocument/2006/relationships/slide" Target="../slides/slide6.xml"/>
</Relationships>
</file>

<file path=ppt/notesSlides/_rels/notesSlide2.xml.rels><?xml version = '1.0' encoding = 'UTF-8' standalone = 'yes'?>
<Relationships xmlns="http://schemas.openxmlformats.org/package/2006/relationships">
   <Relationship Id="rId1" Type="http://schemas.openxmlformats.org/officeDocument/2006/relationships/notesMaster" Target="../notesMasters/notesMaster1.xml"/>
   <Relationship Id="rId2" Type="http://schemas.openxmlformats.org/officeDocument/2006/relationships/slide" Target="../slides/slide7.xml"/>
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HPAT3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426E606-3D27-4AB1-8873-A0DD79BBB60F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654631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HPAT2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426E606-3D27-4AB1-8873-A0DD79BBB60F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8449850"/>
      </p:ext>
    </p:extLst>
  </p:cSld>
  <p:clrMapOvr>
    <a:masterClrMapping/>
  </p:clrMapOvr>
</p:note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8569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8049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5840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68128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39024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48812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06517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12374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34664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633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744470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0844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</Relationships>
</file>

<file path=ppt/slides/_rels/slide2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</Relationships>
</file>

<file path=ppt/slides/_rels/slide3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</Relationships>
</file>

<file path=ppt/slides/_rels/slide4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</Relationships>
</file>

<file path=ppt/slides/_rels/slide5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   <Relationship Id="rId2" Type="http://schemas.openxmlformats.org/officeDocument/2006/relationships/image" Target="../media/image1.emf"/>
</Relationships>
</file>

<file path=ppt/slides/_rels/slide6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   <Relationship Id="rId2" Type="http://schemas.openxmlformats.org/officeDocument/2006/relationships/notesSlide" Target="../notesSlides/notesSlide1.xml"/>
   <Relationship Id="rId3" Type="http://schemas.openxmlformats.org/officeDocument/2006/relationships/image" Target="../media/image2.emf"/>
</Relationships>
</file>

<file path=ppt/slides/_rels/slide7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   <Relationship Id="rId2" Type="http://schemas.openxmlformats.org/officeDocument/2006/relationships/notesSlide" Target="../notesSlides/notesSlide2.xml"/>
   <Relationship Id="rId3" Type="http://schemas.openxmlformats.org/officeDocument/2006/relationships/image" Target="../media/image3.emf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846161" y="2445689"/>
            <a:ext cx="10781732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1000"/>
              </a:spcAft>
            </a:pPr>
            <a:r>
              <a:rPr lang="en-US" sz="16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S9.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 overview of identification and characterization of novel primate-specific transposable element-derived </a:t>
            </a:r>
            <a:r>
              <a:rPr lang="en-US" sz="16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incRNAs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laying mechanistically distinct roles of human preimplantation development and contributing to the pluripotency maintenance and UCSC Genome Browser windows revealing systematic deletion patterns of ancestral DNA in primate-specific retrotransposon-derived </a:t>
            </a:r>
            <a:r>
              <a:rPr lang="en-US" sz="16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incRNAs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xpressed in human embryos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980251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53320" y="1572739"/>
            <a:ext cx="9739952" cy="2275930"/>
          </a:xfrm>
        </p:spPr>
        <p:txBody>
          <a:bodyPr>
            <a:normAutofit fontScale="90000"/>
          </a:bodyPr>
          <a:lstStyle/>
          <a:p>
            <a:r>
              <a:rPr lang="en-US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FLOW CHART OF IDENTIFICATION AND CHARACTERIZATION OF NOVEL TRANSPOSABLE ELEMENTS-DERIVED </a:t>
            </a:r>
            <a:r>
              <a:rPr lang="en-US" sz="2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incRNAs</a:t>
            </a:r>
            <a:r>
              <a:rPr lang="en-US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 PLAYING MECHANISTICALLY DISTINCT ROLES IN MAINTENANCE OF PLURIPOTENCY AND HUMAN PREIMPLANTATION DEVELOPMENT</a:t>
            </a:r>
            <a:endParaRPr 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622588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09433" y="442517"/>
            <a:ext cx="11191163" cy="769126"/>
          </a:xfrm>
          <a:prstGeom prst="rect">
            <a:avLst/>
          </a:prstGeom>
          <a:solidFill>
            <a:schemeClr val="bg1"/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/>
          <p:cNvSpPr/>
          <p:nvPr/>
        </p:nvSpPr>
        <p:spPr>
          <a:xfrm>
            <a:off x="409433" y="1500221"/>
            <a:ext cx="11191163" cy="560608"/>
          </a:xfrm>
          <a:prstGeom prst="rect">
            <a:avLst/>
          </a:prstGeom>
          <a:solidFill>
            <a:schemeClr val="bg1"/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409433" y="518294"/>
            <a:ext cx="1119116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Hybrid RNA sequencing technology identifies 2,103 novel transcript isoforms, 273 of which </a:t>
            </a:r>
          </a:p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were transcribed from 216 novel gene loci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409433" y="2380501"/>
            <a:ext cx="11191164" cy="1023759"/>
          </a:xfrm>
          <a:prstGeom prst="rect">
            <a:avLst/>
          </a:prstGeom>
          <a:solidFill>
            <a:schemeClr val="bg1"/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409433" y="2430715"/>
            <a:ext cx="1119116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23 transcripts (15.7%) most abundantly expressed in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luripotent </a:t>
            </a:r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ESCs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d termed  </a:t>
            </a:r>
          </a:p>
          <a:p>
            <a:pPr algn="ctr"/>
            <a:r>
              <a:rPr lang="en-US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Human Pluripotency-Associated Transcripts 1-23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HPAT1-23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) were defined as novel </a:t>
            </a:r>
          </a:p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ransposable elements (TE) - derived </a:t>
            </a:r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incRNAs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173704" y="1598971"/>
            <a:ext cx="98946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Transcripts of 146 novel genes (68%) expressed specifically in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luripotent </a:t>
            </a:r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hESCs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409433" y="3692811"/>
            <a:ext cx="11191164" cy="1180615"/>
          </a:xfrm>
          <a:prstGeom prst="rect">
            <a:avLst/>
          </a:prstGeom>
          <a:solidFill>
            <a:schemeClr val="bg1"/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409433" y="3821453"/>
            <a:ext cx="1119116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ingle-cell gene expression analysis of 23 </a:t>
            </a:r>
            <a:r>
              <a:rPr lang="en-US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HPATs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in human blastocysts and a single-cell time-course expression profiling of nuclear reprogramming to generate </a:t>
            </a:r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identifies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3 TE-derived </a:t>
            </a:r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incRNAs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associated with pluripotency in human embryos (</a:t>
            </a:r>
            <a:r>
              <a:rPr lang="en-US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HPAT-2, -3, -5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409433" y="5177582"/>
            <a:ext cx="11191164" cy="1337480"/>
          </a:xfrm>
          <a:prstGeom prst="rect">
            <a:avLst/>
          </a:prstGeom>
          <a:solidFill>
            <a:schemeClr val="bg1"/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>
            <a:off x="409433" y="5246156"/>
            <a:ext cx="1119116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CRISPR-mediated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isruption of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these genes, gene transfer and gene knockdown experiments coupled with structure-function relationships analyses of 3 TE-derived </a:t>
            </a:r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incRNAs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associated with pluripotency in human embryos (</a:t>
            </a:r>
            <a:r>
              <a:rPr lang="en-US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HPAT-2, -3, -5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) demonstrate their essential and mechanistically distinct roles in maintenance of pluripotency and human preimplantation development 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Straight Arrow Connector 16"/>
          <p:cNvCxnSpPr/>
          <p:nvPr/>
        </p:nvCxnSpPr>
        <p:spPr>
          <a:xfrm>
            <a:off x="6121013" y="2091949"/>
            <a:ext cx="2" cy="271275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>
            <a:off x="6121011" y="3428557"/>
            <a:ext cx="2" cy="271275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>
            <a:off x="6121009" y="4902315"/>
            <a:ext cx="2" cy="271275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/>
          <p:nvPr/>
        </p:nvCxnSpPr>
        <p:spPr>
          <a:xfrm>
            <a:off x="6114167" y="1235940"/>
            <a:ext cx="2" cy="271275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175942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r>
              <a:rPr lang="en-US" sz="4800" dirty="0" smtClean="0"/>
              <a:t>UCSC Genome Browser views of HPAT </a:t>
            </a:r>
            <a:r>
              <a:rPr lang="en-US" sz="4800" dirty="0" err="1" smtClean="0"/>
              <a:t>lincRNAs</a:t>
            </a:r>
            <a:r>
              <a:rPr lang="en-US" sz="4800" dirty="0" smtClean="0"/>
              <a:t>’ sequences indicating the sites of the deletions of ancestral DNA </a:t>
            </a:r>
            <a:endParaRPr lang="en-US" sz="4800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 smtClean="0"/>
              <a:t>B, Bonobo; C, Chimpanzee; G, Gorilla; O, Orangutan;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563304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421" y="95532"/>
            <a:ext cx="11805313" cy="6619165"/>
          </a:xfrm>
          <a:prstGeom prst="rect">
            <a:avLst/>
          </a:prstGeom>
        </p:spPr>
      </p:pic>
      <p:cxnSp>
        <p:nvCxnSpPr>
          <p:cNvPr id="4" name="Straight Arrow Connector 3"/>
          <p:cNvCxnSpPr/>
          <p:nvPr/>
        </p:nvCxnSpPr>
        <p:spPr>
          <a:xfrm>
            <a:off x="5022376" y="341194"/>
            <a:ext cx="13648" cy="225188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/>
          <p:cNvCxnSpPr/>
          <p:nvPr/>
        </p:nvCxnSpPr>
        <p:spPr>
          <a:xfrm>
            <a:off x="5515969" y="341194"/>
            <a:ext cx="13648" cy="225188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/>
          <p:cNvCxnSpPr/>
          <p:nvPr/>
        </p:nvCxnSpPr>
        <p:spPr>
          <a:xfrm>
            <a:off x="5666095" y="341193"/>
            <a:ext cx="13648" cy="225188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>
            <a:off x="6541825" y="361720"/>
            <a:ext cx="13648" cy="225188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>
            <a:off x="7426653" y="348072"/>
            <a:ext cx="13648" cy="225188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/>
          <p:nvPr/>
        </p:nvCxnSpPr>
        <p:spPr>
          <a:xfrm>
            <a:off x="7999865" y="361720"/>
            <a:ext cx="13648" cy="225188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4722125" y="1899313"/>
            <a:ext cx="259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7672315" y="1899311"/>
            <a:ext cx="25930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5256661" y="1899312"/>
            <a:ext cx="259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659270" y="1899313"/>
            <a:ext cx="25930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6521357" y="1899311"/>
            <a:ext cx="259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7192372" y="1899311"/>
            <a:ext cx="259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Straight Arrow Connector 16"/>
          <p:cNvCxnSpPr/>
          <p:nvPr/>
        </p:nvCxnSpPr>
        <p:spPr>
          <a:xfrm>
            <a:off x="8068107" y="361719"/>
            <a:ext cx="13648" cy="225188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8023745" y="1899309"/>
            <a:ext cx="259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cxnSp>
        <p:nvCxnSpPr>
          <p:cNvPr id="20" name="Straight Arrow Connector 19"/>
          <p:cNvCxnSpPr/>
          <p:nvPr/>
        </p:nvCxnSpPr>
        <p:spPr>
          <a:xfrm>
            <a:off x="9716072" y="386094"/>
            <a:ext cx="13648" cy="225188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/>
          <p:nvPr/>
        </p:nvCxnSpPr>
        <p:spPr>
          <a:xfrm>
            <a:off x="8844320" y="348072"/>
            <a:ext cx="13648" cy="225188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>
            <a:off x="10961425" y="386093"/>
            <a:ext cx="13648" cy="225188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/>
          <p:nvPr/>
        </p:nvCxnSpPr>
        <p:spPr>
          <a:xfrm>
            <a:off x="11066057" y="386093"/>
            <a:ext cx="13648" cy="225188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8548618" y="1899310"/>
            <a:ext cx="259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9429467" y="1899309"/>
            <a:ext cx="259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1038763" y="1899309"/>
            <a:ext cx="259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10708941" y="1899309"/>
            <a:ext cx="259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-25023" y="5358704"/>
            <a:ext cx="152559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PAT5 let7-binding sites</a:t>
            </a:r>
            <a:endParaRPr lang="en-US" sz="1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4118" y="58547"/>
            <a:ext cx="7460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PAT5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Straight Arrow Connector 29"/>
          <p:cNvCxnSpPr/>
          <p:nvPr/>
        </p:nvCxnSpPr>
        <p:spPr>
          <a:xfrm>
            <a:off x="780195" y="3057099"/>
            <a:ext cx="4230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/>
          <p:nvPr/>
        </p:nvCxnSpPr>
        <p:spPr>
          <a:xfrm>
            <a:off x="780195" y="3264090"/>
            <a:ext cx="4230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/>
          <p:cNvCxnSpPr/>
          <p:nvPr/>
        </p:nvCxnSpPr>
        <p:spPr>
          <a:xfrm>
            <a:off x="780195" y="3168556"/>
            <a:ext cx="4230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Oval 2"/>
          <p:cNvSpPr/>
          <p:nvPr/>
        </p:nvSpPr>
        <p:spPr>
          <a:xfrm>
            <a:off x="7901838" y="5455487"/>
            <a:ext cx="260665" cy="292388"/>
          </a:xfrm>
          <a:prstGeom prst="ellipse">
            <a:avLst/>
          </a:prstGeom>
          <a:noFill/>
          <a:ln w="381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Oval 32"/>
          <p:cNvSpPr/>
          <p:nvPr/>
        </p:nvSpPr>
        <p:spPr>
          <a:xfrm>
            <a:off x="7901838" y="1574781"/>
            <a:ext cx="260665" cy="292388"/>
          </a:xfrm>
          <a:prstGeom prst="ellipse">
            <a:avLst/>
          </a:prstGeom>
          <a:noFill/>
          <a:ln w="381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Oval 33"/>
          <p:cNvSpPr/>
          <p:nvPr/>
        </p:nvSpPr>
        <p:spPr>
          <a:xfrm>
            <a:off x="1500571" y="5455487"/>
            <a:ext cx="260665" cy="292388"/>
          </a:xfrm>
          <a:prstGeom prst="ellipse">
            <a:avLst/>
          </a:prstGeom>
          <a:noFill/>
          <a:ln w="381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TextBox 34"/>
          <p:cNvSpPr txBox="1"/>
          <p:nvPr/>
        </p:nvSpPr>
        <p:spPr>
          <a:xfrm>
            <a:off x="-25023" y="4787093"/>
            <a:ext cx="161043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letion sites of ancestral DNA</a:t>
            </a:r>
            <a:endParaRPr lang="en-US" sz="1400" b="1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Straight Arrow Connector 35"/>
          <p:cNvCxnSpPr/>
          <p:nvPr/>
        </p:nvCxnSpPr>
        <p:spPr>
          <a:xfrm>
            <a:off x="1630904" y="4817840"/>
            <a:ext cx="13649" cy="4481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800782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3773" y="95535"/>
            <a:ext cx="11791666" cy="6660108"/>
          </a:xfrm>
          <a:prstGeom prst="rect">
            <a:avLst/>
          </a:prstGeom>
        </p:spPr>
      </p:pic>
      <p:cxnSp>
        <p:nvCxnSpPr>
          <p:cNvPr id="3" name="Straight Arrow Connector 2"/>
          <p:cNvCxnSpPr/>
          <p:nvPr/>
        </p:nvCxnSpPr>
        <p:spPr>
          <a:xfrm>
            <a:off x="780196" y="3195851"/>
            <a:ext cx="4230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Arrow Connector 3"/>
          <p:cNvCxnSpPr/>
          <p:nvPr/>
        </p:nvCxnSpPr>
        <p:spPr>
          <a:xfrm>
            <a:off x="780196" y="3075296"/>
            <a:ext cx="4230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/>
          <p:cNvCxnSpPr/>
          <p:nvPr/>
        </p:nvCxnSpPr>
        <p:spPr>
          <a:xfrm>
            <a:off x="5950423" y="218364"/>
            <a:ext cx="13648" cy="225188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5691115" y="1462582"/>
            <a:ext cx="25930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8709546" y="218363"/>
            <a:ext cx="13648" cy="225188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8463886" y="1870124"/>
            <a:ext cx="25930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cxnSp>
        <p:nvCxnSpPr>
          <p:cNvPr id="9" name="Straight Arrow Connector 8"/>
          <p:cNvCxnSpPr/>
          <p:nvPr/>
        </p:nvCxnSpPr>
        <p:spPr>
          <a:xfrm>
            <a:off x="6023209" y="218363"/>
            <a:ext cx="13648" cy="225188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5986818" y="1678025"/>
            <a:ext cx="25930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3976048" y="218363"/>
            <a:ext cx="13648" cy="225188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3965809" y="1893468"/>
            <a:ext cx="259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4118" y="58547"/>
            <a:ext cx="7460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PAT3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Straight Arrow Connector 13"/>
          <p:cNvCxnSpPr/>
          <p:nvPr/>
        </p:nvCxnSpPr>
        <p:spPr>
          <a:xfrm>
            <a:off x="3896439" y="218363"/>
            <a:ext cx="13648" cy="225188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3625758" y="1893467"/>
            <a:ext cx="259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</p:txBody>
      </p:sp>
      <p:cxnSp>
        <p:nvCxnSpPr>
          <p:cNvPr id="16" name="Straight Arrow Connector 15"/>
          <p:cNvCxnSpPr/>
          <p:nvPr/>
        </p:nvCxnSpPr>
        <p:spPr>
          <a:xfrm>
            <a:off x="6994486" y="218363"/>
            <a:ext cx="13648" cy="225188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6976277" y="1893466"/>
            <a:ext cx="259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</p:txBody>
      </p:sp>
      <p:cxnSp>
        <p:nvCxnSpPr>
          <p:cNvPr id="18" name="Straight Arrow Connector 17"/>
          <p:cNvCxnSpPr/>
          <p:nvPr/>
        </p:nvCxnSpPr>
        <p:spPr>
          <a:xfrm>
            <a:off x="8747075" y="212435"/>
            <a:ext cx="13648" cy="225188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8747075" y="1870124"/>
            <a:ext cx="259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</p:txBody>
      </p:sp>
      <p:cxnSp>
        <p:nvCxnSpPr>
          <p:cNvPr id="20" name="Straight Arrow Connector 19"/>
          <p:cNvCxnSpPr/>
          <p:nvPr/>
        </p:nvCxnSpPr>
        <p:spPr>
          <a:xfrm>
            <a:off x="10296101" y="212435"/>
            <a:ext cx="13648" cy="225188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10304061" y="1870124"/>
            <a:ext cx="259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-25023" y="5073696"/>
            <a:ext cx="161043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letion sites of ancestral DNA</a:t>
            </a:r>
            <a:endParaRPr lang="en-US" sz="1400" b="1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Straight Arrow Connector 22"/>
          <p:cNvCxnSpPr/>
          <p:nvPr/>
        </p:nvCxnSpPr>
        <p:spPr>
          <a:xfrm>
            <a:off x="1630904" y="5104443"/>
            <a:ext cx="13649" cy="4481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100382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6479" y="95535"/>
            <a:ext cx="11928142" cy="6660108"/>
          </a:xfrm>
          <a:prstGeom prst="rect">
            <a:avLst/>
          </a:prstGeom>
        </p:spPr>
      </p:pic>
      <p:cxnSp>
        <p:nvCxnSpPr>
          <p:cNvPr id="3" name="Straight Arrow Connector 2"/>
          <p:cNvCxnSpPr/>
          <p:nvPr/>
        </p:nvCxnSpPr>
        <p:spPr>
          <a:xfrm>
            <a:off x="575479" y="3427863"/>
            <a:ext cx="4230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Arrow Connector 3"/>
          <p:cNvCxnSpPr/>
          <p:nvPr/>
        </p:nvCxnSpPr>
        <p:spPr>
          <a:xfrm>
            <a:off x="575479" y="3618932"/>
            <a:ext cx="4230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/>
          <p:cNvCxnSpPr/>
          <p:nvPr/>
        </p:nvCxnSpPr>
        <p:spPr>
          <a:xfrm>
            <a:off x="8450244" y="375367"/>
            <a:ext cx="25016" cy="229959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>
            <a:off x="10142567" y="375367"/>
            <a:ext cx="25015" cy="229959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9883259" y="1912961"/>
            <a:ext cx="259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8165921" y="1912961"/>
            <a:ext cx="259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4118" y="58547"/>
            <a:ext cx="7460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PAT2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-25023" y="5455833"/>
            <a:ext cx="161043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letion sites of ancestral DNA</a:t>
            </a:r>
            <a:endParaRPr lang="en-US" sz="1400" b="1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1630904" y="5486580"/>
            <a:ext cx="13649" cy="4481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978801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2</TotalTime>
  <Words>319</Words>
  <Application>Microsoft Office PowerPoint</Application>
  <PresentationFormat>Widescreen</PresentationFormat>
  <Paragraphs>52</Paragraphs>
  <Slides>7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 Theme</vt:lpstr>
      <vt:lpstr>PowerPoint Presentation</vt:lpstr>
      <vt:lpstr>FLOW CHART OF IDENTIFICATION AND CHARACTERIZATION OF NOVEL TRANSPOSABLE ELEMENTS-DERIVED lincRNAs PLAYING MECHANISTICALLY DISTINCT ROLES IN MAINTENANCE OF PLURIPOTENCY AND HUMAN PREIMPLANTATION DEVELOPMENT</vt:lpstr>
      <vt:lpstr>PowerPoint Presentation</vt:lpstr>
      <vt:lpstr>UCSC Genome Browser views of HPAT lincRNAs’ sequences indicating the sites of the deletions of ancestral DNA </vt:lpstr>
      <vt:lpstr>PowerPoint Presentation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